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04" r:id="rId2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869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73" autoAdjust="0"/>
    <p:restoredTop sz="74510" autoAdjust="0"/>
  </p:normalViewPr>
  <p:slideViewPr>
    <p:cSldViewPr snapToGrid="0">
      <p:cViewPr varScale="1">
        <p:scale>
          <a:sx n="61" d="100"/>
          <a:sy n="61" d="100"/>
        </p:scale>
        <p:origin x="2670" y="66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8B7A6-A418-4C37-8DE7-370EEF89986F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0C8CD-7C34-44D0-AB1A-3784C5385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220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E07137-4C81-5B65-626D-6413B060C9F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D259849-D012-271C-E540-44E7AEB49D7C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502A9878-A50E-16CC-0B9B-F86C64BDD7C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g. S2: Optimized treatment parameters for </a:t>
            </a:r>
            <a:r>
              <a:rPr lang="en-US" sz="1200" b="1" i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. aeruginosa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stimulation provide robust immune response in control PBMCs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Scatter plots showing immune response from healthy control PBMCs after 24-hour stimulation with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timulation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MHC-II expression (Treatmen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= 0.0002),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B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percentage of live cells (Treatmen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= 0.0405), and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C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live cell counts (Treatmen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= 0.1589) after 24-hour stimulation with various multiplicities of infection. (D-H) display the secretion of proinflammatory cytokines comparing vehicle treatment to MOI=10 of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timulation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IL-10 secretion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E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IL-1</a:t>
            </a:r>
            <a:r>
              <a:rPr lang="el-GR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β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secretion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IL-2 secretion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G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IL-8 secretion. (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H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TNF secretion. Each symbol represents the measurement from a single individual. A-C were analyzed using one-way ANOVA with Dunnet’s test for multiple comparisons. D-H were analyzed using student’s t test. Bars represent the mean +/- SEM. Only statistically significant 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values (</a:t>
            </a:r>
            <a:r>
              <a:rPr lang="en-US" sz="1200" i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 </a:t>
            </a:r>
            <a:r>
              <a:rPr lang="en-US" sz="1200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&lt; 0.05) are shown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E52945-A7D5-9D68-6934-3D470922232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F0C8CD-7C34-44D0-AB1A-3784C53859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1704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878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385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986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11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260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196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14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3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077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813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174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8C8883-C0BB-4EFA-870D-8ECEB2739B33}" type="datetimeFigureOut">
              <a:rPr lang="en-US" smtClean="0"/>
              <a:t>10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944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D77869-B32C-5BAC-66FD-5E8527C716C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67A729F4-B313-BCD1-A317-9BD92B8D3E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97228" y="688496"/>
            <a:ext cx="2362748" cy="288036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99ECD21-AAC4-53DD-C3D5-9D3F615B24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5796" y="694801"/>
            <a:ext cx="2428778" cy="28803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CF95999-D750-131D-1CE2-3199F8CE9AE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82394" y="683727"/>
            <a:ext cx="2567810" cy="28803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A098BB7-76C1-D15C-498A-7FD3A5B4B365}"/>
              </a:ext>
            </a:extLst>
          </p:cNvPr>
          <p:cNvSpPr txBox="1"/>
          <p:nvPr/>
        </p:nvSpPr>
        <p:spPr>
          <a:xfrm>
            <a:off x="134863" y="692287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4EEB141-7FB4-9210-816A-C8CFF4F9136F}"/>
              </a:ext>
            </a:extLst>
          </p:cNvPr>
          <p:cNvSpPr txBox="1"/>
          <p:nvPr/>
        </p:nvSpPr>
        <p:spPr>
          <a:xfrm>
            <a:off x="2987824" y="692946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3475C06-C484-D206-C56F-F638320B6849}"/>
              </a:ext>
            </a:extLst>
          </p:cNvPr>
          <p:cNvSpPr txBox="1"/>
          <p:nvPr/>
        </p:nvSpPr>
        <p:spPr>
          <a:xfrm>
            <a:off x="5867155" y="694270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2EACC25-FA9E-0CD0-A769-011C9A6E977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1889" y="3588058"/>
            <a:ext cx="1797472" cy="310896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FB957E57-96DA-1BC5-939F-993C489DA0F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18694" y="3596347"/>
            <a:ext cx="1824966" cy="310896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D77AE6B-3AC1-BC95-A5CB-8C29B4C5F7B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85374" y="3590346"/>
            <a:ext cx="1711896" cy="310896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E914ABD-A8CC-6ACD-331B-B198CE63369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014451" y="3568249"/>
            <a:ext cx="1836516" cy="310896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986A347-4993-AB1C-C10E-23FA9F5D5C8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007318" y="3563254"/>
            <a:ext cx="1836516" cy="310896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7476B3FF-4B73-F146-4E0F-55A9E0B3EE67}"/>
              </a:ext>
            </a:extLst>
          </p:cNvPr>
          <p:cNvSpPr txBox="1"/>
          <p:nvPr/>
        </p:nvSpPr>
        <p:spPr>
          <a:xfrm>
            <a:off x="143167" y="3605762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B5E61B4-009C-1D31-2642-AD918B2FE48D}"/>
              </a:ext>
            </a:extLst>
          </p:cNvPr>
          <p:cNvSpPr txBox="1"/>
          <p:nvPr/>
        </p:nvSpPr>
        <p:spPr>
          <a:xfrm>
            <a:off x="2123294" y="3606421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30F79BC-1241-203A-6D81-B755D41A7155}"/>
              </a:ext>
            </a:extLst>
          </p:cNvPr>
          <p:cNvSpPr txBox="1"/>
          <p:nvPr/>
        </p:nvSpPr>
        <p:spPr>
          <a:xfrm>
            <a:off x="4088219" y="3607745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14A77E4-ABEA-8F0D-2C0B-5B525D0AFFEC}"/>
              </a:ext>
            </a:extLst>
          </p:cNvPr>
          <p:cNvSpPr txBox="1"/>
          <p:nvPr/>
        </p:nvSpPr>
        <p:spPr>
          <a:xfrm>
            <a:off x="6040173" y="3607110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DD04757-C10B-2161-4165-4E7391998018}"/>
              </a:ext>
            </a:extLst>
          </p:cNvPr>
          <p:cNvSpPr txBox="1"/>
          <p:nvPr/>
        </p:nvSpPr>
        <p:spPr>
          <a:xfrm>
            <a:off x="8010778" y="3602616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5C99FF-4ACD-5440-D46F-597F9E6E43D1}"/>
              </a:ext>
            </a:extLst>
          </p:cNvPr>
          <p:cNvSpPr txBox="1"/>
          <p:nvPr/>
        </p:nvSpPr>
        <p:spPr>
          <a:xfrm>
            <a:off x="1" y="6745089"/>
            <a:ext cx="9843834" cy="16589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g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S2: 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Optimized treatment parameters for </a:t>
            </a:r>
            <a:r>
              <a:rPr lang="en-US" sz="1200" b="1" i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. aeruginosa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stimulation provide robust immune response in control PBMCs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Scatter plots showing immune response from healthy control PBMCs after 24-hour stimulation with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timulation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MHC-II expression (Treatmen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= 0.0002),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B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percentage of live cells (Treatmen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= 0.0405), and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C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live cell counts (Treatmen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= 0.1589) after 24-hour stimulation with various multiplicities of infection. (D-H) display the secretion of proinflammatory cytokines comparing vehicle treatment to MOI=10 of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timulation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IL-10 secretion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E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IL-1</a:t>
            </a:r>
            <a:r>
              <a:rPr lang="el-GR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β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secretion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IL-2 secretion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G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IL-8 secretion. (</a:t>
            </a: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H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TNF secretion. Each symbol represents the measurement from a single individual. A-C were analyzed using one-way ANOVA with Dunnet’s test for multiple comparisons. D-H were analyzed using student’s t test. Bars represent the mean +/- SEM. Only statistically significant 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values (</a:t>
            </a:r>
            <a:r>
              <a:rPr lang="en-US" sz="1200" i="1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&lt; 0.05) are shown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6D75CB5-4C25-A66D-CEC4-B951184DB598}"/>
              </a:ext>
            </a:extLst>
          </p:cNvPr>
          <p:cNvSpPr txBox="1"/>
          <p:nvPr/>
        </p:nvSpPr>
        <p:spPr>
          <a:xfrm>
            <a:off x="0" y="0"/>
            <a:ext cx="82671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/>
              <a:t>Fig. S2</a:t>
            </a:r>
            <a:endParaRPr 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3275429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924</TotalTime>
  <Words>388</Words>
  <Application>Microsoft Office PowerPoint</Application>
  <PresentationFormat>Custom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RRK2/GBA1 mutations peripheral immune cells in Parkinson’s disease</dc:title>
  <dc:creator>Julian Mark</dc:creator>
  <cp:lastModifiedBy>Mark, Julian</cp:lastModifiedBy>
  <cp:revision>796</cp:revision>
  <dcterms:created xsi:type="dcterms:W3CDTF">2025-01-19T15:31:25Z</dcterms:created>
  <dcterms:modified xsi:type="dcterms:W3CDTF">2025-10-26T19:20:13Z</dcterms:modified>
</cp:coreProperties>
</file>